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171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D4E2EB-A6A9-416F-84F3-ADBDEE3DD587}" type="datetimeFigureOut">
              <a:rPr lang="ko-KR" altLang="en-US" smtClean="0"/>
              <a:t>2022-08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21224B-C831-4692-8769-631AE08BE83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38528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D4E2EB-A6A9-416F-84F3-ADBDEE3DD587}" type="datetimeFigureOut">
              <a:rPr lang="ko-KR" altLang="en-US" smtClean="0"/>
              <a:t>2022-08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21224B-C831-4692-8769-631AE08BE83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147374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D4E2EB-A6A9-416F-84F3-ADBDEE3DD587}" type="datetimeFigureOut">
              <a:rPr lang="ko-KR" altLang="en-US" smtClean="0"/>
              <a:t>2022-08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21224B-C831-4692-8769-631AE08BE83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78012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D4E2EB-A6A9-416F-84F3-ADBDEE3DD587}" type="datetimeFigureOut">
              <a:rPr lang="ko-KR" altLang="en-US" smtClean="0"/>
              <a:t>2022-08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21224B-C831-4692-8769-631AE08BE83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484071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D4E2EB-A6A9-416F-84F3-ADBDEE3DD587}" type="datetimeFigureOut">
              <a:rPr lang="ko-KR" altLang="en-US" smtClean="0"/>
              <a:t>2022-08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21224B-C831-4692-8769-631AE08BE83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497685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D4E2EB-A6A9-416F-84F3-ADBDEE3DD587}" type="datetimeFigureOut">
              <a:rPr lang="ko-KR" altLang="en-US" smtClean="0"/>
              <a:t>2022-08-0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21224B-C831-4692-8769-631AE08BE83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150351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D4E2EB-A6A9-416F-84F3-ADBDEE3DD587}" type="datetimeFigureOut">
              <a:rPr lang="ko-KR" altLang="en-US" smtClean="0"/>
              <a:t>2022-08-0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21224B-C831-4692-8769-631AE08BE83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262513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D4E2EB-A6A9-416F-84F3-ADBDEE3DD587}" type="datetimeFigureOut">
              <a:rPr lang="ko-KR" altLang="en-US" smtClean="0"/>
              <a:t>2022-08-0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21224B-C831-4692-8769-631AE08BE83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760568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D4E2EB-A6A9-416F-84F3-ADBDEE3DD587}" type="datetimeFigureOut">
              <a:rPr lang="ko-KR" altLang="en-US" smtClean="0"/>
              <a:t>2022-08-0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21224B-C831-4692-8769-631AE08BE83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500497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D4E2EB-A6A9-416F-84F3-ADBDEE3DD587}" type="datetimeFigureOut">
              <a:rPr lang="ko-KR" altLang="en-US" smtClean="0"/>
              <a:t>2022-08-0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21224B-C831-4692-8769-631AE08BE83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435284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D4E2EB-A6A9-416F-84F3-ADBDEE3DD587}" type="datetimeFigureOut">
              <a:rPr lang="ko-KR" altLang="en-US" smtClean="0"/>
              <a:t>2022-08-0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21224B-C831-4692-8769-631AE08BE83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395339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D4E2EB-A6A9-416F-84F3-ADBDEE3DD587}" type="datetimeFigureOut">
              <a:rPr lang="ko-KR" altLang="en-US" smtClean="0"/>
              <a:t>2022-08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21224B-C831-4692-8769-631AE08BE83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352170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ED7E932-D3F8-4B35-827E-5D42C310325B}"/>
              </a:ext>
            </a:extLst>
          </p:cNvPr>
          <p:cNvSpPr txBox="1"/>
          <p:nvPr/>
        </p:nvSpPr>
        <p:spPr>
          <a:xfrm>
            <a:off x="819659" y="4453150"/>
            <a:ext cx="6987910" cy="17260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Figure S1. </a:t>
            </a:r>
            <a:r>
              <a:rPr lang="en-US" altLang="ko-KR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Cytotoxicity of B16F10 cells in response to kojic acid. The cells were exposed to serial concentrations (0, 12.5, 25, 50, 100 and 200 </a:t>
            </a:r>
            <a:r>
              <a:rPr lang="el-GR" altLang="ko-KR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μ</a:t>
            </a:r>
            <a:r>
              <a:rPr lang="en-US" altLang="ko-KR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M) of kojic acid for 24 h, and their viability was measured using Cell Counting Kit-8 (</a:t>
            </a:r>
            <a:r>
              <a:rPr lang="en-US" altLang="ko-KR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Dojindo</a:t>
            </a:r>
            <a:r>
              <a:rPr lang="en-US" altLang="ko-KR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, Kumamoto, Japan). Kojic acid treatment was performed as three independent replicates to guarantee reliable results. To compare the differences among control (0 </a:t>
            </a:r>
            <a:r>
              <a:rPr lang="el-GR" altLang="ko-KR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μ</a:t>
            </a:r>
            <a:r>
              <a:rPr lang="en-US" altLang="ko-KR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M) and kojic acid-treated cells, one-way ANOVA and Tukey’s post-hoc tests were used. *: significantly different from control (*</a:t>
            </a:r>
            <a:r>
              <a:rPr lang="en-US" altLang="ko-KR" sz="1200" i="1" dirty="0">
                <a:latin typeface="Palatino Linotype" panose="02040502050505030304" pitchFamily="18" charset="0"/>
                <a:cs typeface="Arial" panose="020B0604020202020204" pitchFamily="34" charset="0"/>
              </a:rPr>
              <a:t>p</a:t>
            </a:r>
            <a:r>
              <a:rPr lang="en-US" altLang="ko-KR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&lt; 0.05). </a:t>
            </a:r>
            <a:endParaRPr lang="ko-KR" altLang="en-US" sz="1200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grpSp>
        <p:nvGrpSpPr>
          <p:cNvPr id="10" name="그룹 9">
            <a:extLst>
              <a:ext uri="{FF2B5EF4-FFF2-40B4-BE49-F238E27FC236}">
                <a16:creationId xmlns:a16="http://schemas.microsoft.com/office/drawing/2014/main" id="{E749A49D-61C8-4C73-AC5B-2505A811B999}"/>
              </a:ext>
            </a:extLst>
          </p:cNvPr>
          <p:cNvGrpSpPr/>
          <p:nvPr/>
        </p:nvGrpSpPr>
        <p:grpSpPr>
          <a:xfrm>
            <a:off x="2051918" y="1106085"/>
            <a:ext cx="4475283" cy="3229475"/>
            <a:chOff x="1084765" y="1334681"/>
            <a:chExt cx="4475283" cy="3229475"/>
          </a:xfrm>
        </p:grpSpPr>
        <p:pic>
          <p:nvPicPr>
            <p:cNvPr id="2" name="그림 1">
              <a:extLst>
                <a:ext uri="{FF2B5EF4-FFF2-40B4-BE49-F238E27FC236}">
                  <a16:creationId xmlns:a16="http://schemas.microsoft.com/office/drawing/2014/main" id="{5038C2A6-0FB2-4F7F-9B99-B151E1ECEBB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169915" y="1441939"/>
              <a:ext cx="3184602" cy="2883256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ECC63328-C785-475D-8717-1FD27CF4945E}"/>
                </a:ext>
              </a:extLst>
            </p:cNvPr>
            <p:cNvSpPr txBox="1"/>
            <p:nvPr/>
          </p:nvSpPr>
          <p:spPr>
            <a:xfrm>
              <a:off x="1783123" y="1334681"/>
              <a:ext cx="439544" cy="30705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lnSpc>
                  <a:spcPct val="125000"/>
                </a:lnSpc>
              </a:pPr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20</a:t>
              </a:r>
            </a:p>
            <a:p>
              <a:pPr algn="r">
                <a:lnSpc>
                  <a:spcPct val="125000"/>
                </a:lnSpc>
              </a:pPr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10</a:t>
              </a:r>
            </a:p>
            <a:p>
              <a:pPr algn="r">
                <a:lnSpc>
                  <a:spcPct val="125000"/>
                </a:lnSpc>
              </a:pPr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>
                <a:lnSpc>
                  <a:spcPct val="125000"/>
                </a:lnSpc>
              </a:pPr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90</a:t>
              </a:r>
            </a:p>
            <a:p>
              <a:pPr algn="r">
                <a:lnSpc>
                  <a:spcPct val="125000"/>
                </a:lnSpc>
              </a:pPr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  <a:p>
              <a:pPr algn="r">
                <a:lnSpc>
                  <a:spcPct val="125000"/>
                </a:lnSpc>
              </a:pPr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</a:p>
            <a:p>
              <a:pPr algn="r">
                <a:lnSpc>
                  <a:spcPct val="125000"/>
                </a:lnSpc>
              </a:pPr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  <a:p>
              <a:pPr algn="r">
                <a:lnSpc>
                  <a:spcPct val="125000"/>
                </a:lnSpc>
              </a:pPr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  <a:p>
              <a:pPr algn="r">
                <a:lnSpc>
                  <a:spcPct val="125000"/>
                </a:lnSpc>
              </a:pPr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  <a:p>
              <a:pPr algn="r">
                <a:lnSpc>
                  <a:spcPct val="125000"/>
                </a:lnSpc>
              </a:pPr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  <a:p>
              <a:pPr algn="r">
                <a:lnSpc>
                  <a:spcPct val="125000"/>
                </a:lnSpc>
              </a:pPr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  <a:p>
              <a:pPr algn="r">
                <a:lnSpc>
                  <a:spcPct val="125000"/>
                </a:lnSpc>
              </a:pPr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  <a:p>
              <a:pPr algn="r">
                <a:lnSpc>
                  <a:spcPct val="125000"/>
                </a:lnSpc>
              </a:pPr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20894D20-363F-41EE-A7D0-06932E83DA5A}"/>
                </a:ext>
              </a:extLst>
            </p:cNvPr>
            <p:cNvSpPr txBox="1"/>
            <p:nvPr/>
          </p:nvSpPr>
          <p:spPr>
            <a:xfrm rot="16200000">
              <a:off x="736536" y="2769361"/>
              <a:ext cx="207103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ell</a:t>
              </a:r>
              <a:r>
                <a: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viability (%)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189856C-3919-4A07-B3C5-14E1673130E1}"/>
                </a:ext>
              </a:extLst>
            </p:cNvPr>
            <p:cNvSpPr txBox="1"/>
            <p:nvPr/>
          </p:nvSpPr>
          <p:spPr>
            <a:xfrm>
              <a:off x="1084765" y="4287157"/>
              <a:ext cx="12906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Kojic</a:t>
              </a:r>
              <a:r>
                <a: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cid (</a:t>
              </a:r>
              <a:r>
                <a:rPr lang="el-GR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)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691D08F-AE27-4593-8434-33CD52A9C495}"/>
                </a:ext>
              </a:extLst>
            </p:cNvPr>
            <p:cNvSpPr txBox="1"/>
            <p:nvPr/>
          </p:nvSpPr>
          <p:spPr>
            <a:xfrm>
              <a:off x="2375446" y="4287157"/>
              <a:ext cx="31846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0       12.5     </a:t>
              </a:r>
              <a:r>
                <a:rPr lang="en-US" altLang="ko-KR" sz="1200" b="1" spc="-15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 25       </a:t>
              </a:r>
              <a:r>
                <a:rPr lang="en-US" altLang="ko-KR" sz="1200" b="1" spc="-150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0       100       200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155C3F33-81DA-4E0D-A214-10228433D1B9}"/>
                </a:ext>
              </a:extLst>
            </p:cNvPr>
            <p:cNvSpPr txBox="1"/>
            <p:nvPr/>
          </p:nvSpPr>
          <p:spPr>
            <a:xfrm>
              <a:off x="4457701" y="2110155"/>
              <a:ext cx="2648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489948B-E494-41F8-AB04-FB612ABDEBD6}"/>
                </a:ext>
              </a:extLst>
            </p:cNvPr>
            <p:cNvSpPr txBox="1"/>
            <p:nvPr/>
          </p:nvSpPr>
          <p:spPr>
            <a:xfrm>
              <a:off x="4976901" y="2007579"/>
              <a:ext cx="2648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280340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16</TotalTime>
  <Words>137</Words>
  <Application>Microsoft Office PowerPoint</Application>
  <PresentationFormat>화면 슬라이드 쇼(4:3)</PresentationFormat>
  <Paragraphs>19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Palatino Linotype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joumc</dc:creator>
  <cp:lastModifiedBy>ajoumc</cp:lastModifiedBy>
  <cp:revision>15</cp:revision>
  <dcterms:created xsi:type="dcterms:W3CDTF">2022-06-27T13:13:06Z</dcterms:created>
  <dcterms:modified xsi:type="dcterms:W3CDTF">2022-08-02T06:33:46Z</dcterms:modified>
</cp:coreProperties>
</file>